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4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120" y="-72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060" y="1847788"/>
            <a:ext cx="837134" cy="13680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200" y="1851573"/>
            <a:ext cx="881046" cy="1368000"/>
          </a:xfrm>
          <a:prstGeom prst="rect">
            <a:avLst/>
          </a:prstGeom>
        </p:spPr>
      </p:pic>
      <p:sp>
        <p:nvSpPr>
          <p:cNvPr id="4" name="Textfeld 12"/>
          <p:cNvSpPr txBox="1"/>
          <p:nvPr/>
        </p:nvSpPr>
        <p:spPr>
          <a:xfrm>
            <a:off x="-15510" y="318010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-15510" y="10233"/>
            <a:ext cx="2110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9" name="Textfeld 12"/>
          <p:cNvSpPr txBox="1"/>
          <p:nvPr/>
        </p:nvSpPr>
        <p:spPr>
          <a:xfrm>
            <a:off x="1311044" y="318008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204864" y="313699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8" name="Textfeld 13"/>
          <p:cNvSpPr txBox="1"/>
          <p:nvPr/>
        </p:nvSpPr>
        <p:spPr>
          <a:xfrm>
            <a:off x="3573016" y="313699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1" name="Textfeld 14"/>
          <p:cNvSpPr txBox="1"/>
          <p:nvPr/>
        </p:nvSpPr>
        <p:spPr>
          <a:xfrm>
            <a:off x="-15510" y="1851573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feld 13"/>
          <p:cNvSpPr txBox="1"/>
          <p:nvPr/>
        </p:nvSpPr>
        <p:spPr>
          <a:xfrm>
            <a:off x="1317741" y="1851573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" name="Textfeld 18"/>
          <p:cNvSpPr txBox="1"/>
          <p:nvPr/>
        </p:nvSpPr>
        <p:spPr>
          <a:xfrm>
            <a:off x="126479" y="6357679"/>
            <a:ext cx="6552728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alproic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cid (VPA) and Stemreginin-1 (SR-1)-dependent effects on the growth of human hematopoietic stem cells (HSCs)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number, percentage and the viability of CD34+ cells was determined by flow cytometric analyses using a combination of anti-CD34/anti-CD45 mouse monoclonal antibody and 7AAD at day 0 and 14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ulture.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percentage and absolute number of CD34+ cells after 0 days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DIV) (A) as well as the corresponding viability of CD34+ cells after 0 and 14 DIV (B) are depicted for three different donors as their mean ± SD. The percentage and absolute number of CD34+ cells after 0 DIV (C) are depicted for three different donors as their mean ± SD. The corresponding viability of CD34+ cells after 0 and 14 DIV in the presence of 0.5 or 1 µM SR-1 as well as of 1 mM VPA in combination with 0.5 or 1 µM SR-1 (D) is depicted for three different donors as their mean ± SD. The percentage and absolute number of CD34+ cells after 0 DIV (E) are depicted for three different donors as their mean ± SD. The corresponding viability of CD34+ cells after 0 and 14 DIV in the presence of 0.5 or 1 mM VPA (F) is depicted for three different donors as their mean ± SD. (G) The percentage, viability and absolute number of CD34+ cells after 0 DIV are depicted for seven different donors as their mean ± SD. (H) The corresponding amplification of all cells and of CD34+ cells as well as the percentage, viability and absolute number of CD34+ cells are depicted for seven different donors as their mean ± SD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368" y="318616"/>
            <a:ext cx="877970" cy="1368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200" y="325092"/>
            <a:ext cx="837134" cy="136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210" y="313566"/>
            <a:ext cx="900862" cy="1512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415" y="325092"/>
            <a:ext cx="877970" cy="1368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4276" y="325092"/>
            <a:ext cx="837134" cy="13680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1582" y="313566"/>
            <a:ext cx="881046" cy="13680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701" y="313566"/>
            <a:ext cx="1111593" cy="16560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4206" y="313566"/>
            <a:ext cx="1226245" cy="19080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368" y="1847788"/>
            <a:ext cx="877970" cy="13680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8155" y="1851573"/>
            <a:ext cx="1111593" cy="1656000"/>
          </a:xfrm>
          <a:prstGeom prst="rect">
            <a:avLst/>
          </a:prstGeom>
        </p:spPr>
      </p:pic>
      <p:pic>
        <p:nvPicPr>
          <p:cNvPr id="22" name="Grafik 21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352FEA7B-A830-4F43-AF48-59D69543C881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5854" y="1871309"/>
            <a:ext cx="787487" cy="1312477"/>
          </a:xfrm>
          <a:prstGeom prst="rect">
            <a:avLst/>
          </a:prstGeom>
        </p:spPr>
      </p:pic>
      <p:pic>
        <p:nvPicPr>
          <p:cNvPr id="23" name="Grafik 22" descr="Ein Bild, das Gebäude, dunkel, Licht, Fenster enthält.&#10;&#10;Automatisch generierte Beschreibung">
            <a:extLst>
              <a:ext uri="{FF2B5EF4-FFF2-40B4-BE49-F238E27FC236}">
                <a16:creationId xmlns:a16="http://schemas.microsoft.com/office/drawing/2014/main" xmlns="" id="{F39882C5-6F60-6648-ABD1-6B96810E6DFC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0866" y="1871310"/>
            <a:ext cx="807677" cy="1312476"/>
          </a:xfrm>
          <a:prstGeom prst="rect">
            <a:avLst/>
          </a:prstGeom>
        </p:spPr>
      </p:pic>
      <p:pic>
        <p:nvPicPr>
          <p:cNvPr id="24" name="Grafik 23" descr="Ein Bild, das dunkel, sitzend, schwarz, erleuchtet enthält.&#10;&#10;Automatisch generierte Beschreibung">
            <a:extLst>
              <a:ext uri="{FF2B5EF4-FFF2-40B4-BE49-F238E27FC236}">
                <a16:creationId xmlns:a16="http://schemas.microsoft.com/office/drawing/2014/main" xmlns="" id="{E74F8EA4-7F5E-234D-B093-B5BE22F56FFF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0390" y="1871309"/>
            <a:ext cx="780143" cy="1312477"/>
          </a:xfrm>
          <a:prstGeom prst="rect">
            <a:avLst/>
          </a:prstGeom>
        </p:spPr>
      </p:pic>
      <p:sp>
        <p:nvSpPr>
          <p:cNvPr id="34" name="Textfeld 16">
            <a:extLst>
              <a:ext uri="{FF2B5EF4-FFF2-40B4-BE49-F238E27FC236}">
                <a16:creationId xmlns:a16="http://schemas.microsoft.com/office/drawing/2014/main" xmlns="" id="{AE019D57-57B0-064E-B9EE-44FB8114931E}"/>
              </a:ext>
            </a:extLst>
          </p:cNvPr>
          <p:cNvSpPr txBox="1"/>
          <p:nvPr/>
        </p:nvSpPr>
        <p:spPr>
          <a:xfrm>
            <a:off x="3119770" y="1851895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35" name="Grafik 34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C614F503-2321-E541-867D-2B80A05FDEA2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940" y="3435786"/>
            <a:ext cx="2074405" cy="1440000"/>
          </a:xfrm>
          <a:prstGeom prst="rect">
            <a:avLst/>
          </a:prstGeom>
        </p:spPr>
      </p:pic>
      <p:pic>
        <p:nvPicPr>
          <p:cNvPr id="36" name="Grafik 35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C316E57C-6810-474F-A4C9-2EB022FF331E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149" y="3435786"/>
            <a:ext cx="2025931" cy="1440000"/>
          </a:xfrm>
          <a:prstGeom prst="rect">
            <a:avLst/>
          </a:prstGeom>
        </p:spPr>
      </p:pic>
      <p:pic>
        <p:nvPicPr>
          <p:cNvPr id="37" name="Grafik 36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29F4CE46-D7EF-A843-B402-D2C8201BB239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5495" y="3435786"/>
            <a:ext cx="2045793" cy="1440000"/>
          </a:xfrm>
          <a:prstGeom prst="rect">
            <a:avLst/>
          </a:prstGeom>
        </p:spPr>
      </p:pic>
      <p:pic>
        <p:nvPicPr>
          <p:cNvPr id="38" name="Grafik 37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7E33A783-5CFA-F14E-812C-D802F18F5EDB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961" y="4788184"/>
            <a:ext cx="2085517" cy="1440000"/>
          </a:xfrm>
          <a:prstGeom prst="rect">
            <a:avLst/>
          </a:prstGeom>
        </p:spPr>
      </p:pic>
      <p:pic>
        <p:nvPicPr>
          <p:cNvPr id="39" name="Grafik 38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DBABF780-1B9C-E84F-B81E-861443D79B1F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3287" y="4788184"/>
            <a:ext cx="2045793" cy="1440000"/>
          </a:xfrm>
          <a:prstGeom prst="rect">
            <a:avLst/>
          </a:prstGeom>
        </p:spPr>
      </p:pic>
      <p:sp>
        <p:nvSpPr>
          <p:cNvPr id="40" name="Textfeld 16">
            <a:extLst>
              <a:ext uri="{FF2B5EF4-FFF2-40B4-BE49-F238E27FC236}">
                <a16:creationId xmlns:a16="http://schemas.microsoft.com/office/drawing/2014/main" xmlns="" id="{446E9DCE-341A-3D49-9B32-E1EFFF4FF150}"/>
              </a:ext>
            </a:extLst>
          </p:cNvPr>
          <p:cNvSpPr txBox="1"/>
          <p:nvPr/>
        </p:nvSpPr>
        <p:spPr>
          <a:xfrm>
            <a:off x="-14993" y="3348160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88561241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7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599</cp:revision>
  <cp:lastPrinted>2019-07-22T14:46:21Z</cp:lastPrinted>
  <dcterms:created xsi:type="dcterms:W3CDTF">2018-07-30T07:38:54Z</dcterms:created>
  <dcterms:modified xsi:type="dcterms:W3CDTF">2020-06-12T14:39:31Z</dcterms:modified>
</cp:coreProperties>
</file>